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64" r:id="rId2"/>
    <p:sldId id="46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3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7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7A4A54-F9FD-3020-4127-985757500B3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5E233E1-7012-E617-3346-8C3CB38926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FAD911-2AD3-B068-00EF-03EEF99D7D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4C448-8B8E-4C87-A134-89449476375F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EE3B16-5924-E8BC-BA2A-9F7DDADBB9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1A7911-4A1B-3BDF-BCCB-3819A639D7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86444-F0C1-4D7F-8CD5-D22A45C5A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29761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3BBAFF-A343-9CA6-5778-AF7BF6CF08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33994B-0EA1-E834-C928-3F2F037237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9F1522-DD0F-AE09-188A-A14FD5F4A5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4C448-8B8E-4C87-A134-89449476375F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2046D8-AE26-2017-91B3-90FFB8BB41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D2EE35-BFC7-D408-4640-5C19300496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86444-F0C1-4D7F-8CD5-D22A45C5A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8758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B33BA82-D368-122E-E168-9AD4ABC1BC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4AEBC07-039B-8ED0-A2C6-7659030EDD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C85D9B-2473-2693-40AD-54A26BB188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4C448-8B8E-4C87-A134-89449476375F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3E751D-1BFC-71D3-0A0C-1FBF458071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95B28F-45DE-5E14-D7EA-FFF8C7787C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86444-F0C1-4D7F-8CD5-D22A45C5A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02195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5F15E9-96CA-5678-701C-E695C23C20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AE80DE-FC82-263F-BEEC-1E15E46E586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11868E-9896-80AC-0215-E5FAB6F3D4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4C448-8B8E-4C87-A134-89449476375F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47733A-DAB9-98A7-EA3E-E2DB2A6A68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3FEB0D-9E5E-22E7-6D29-ADAEF3930F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86444-F0C1-4D7F-8CD5-D22A45C5A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930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F38E8D-AE77-9AE8-CD93-D2C2ADF93D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DDF9F3-4740-6B77-17D6-2D61DE3155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2DC2C4-4E08-6D3E-40D3-31B7261EA9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4C448-8B8E-4C87-A134-89449476375F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D5F140-0F8D-08C3-2787-28B2C3C2F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85ABC4-BA71-926B-073B-5C27D85FFD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86444-F0C1-4D7F-8CD5-D22A45C5A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20095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91FF2A-57FB-52C1-4D3E-E80B6E9E47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BEAE2E-30D7-EDB3-2D7D-4F098D35A98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335F411-68F4-DE72-A1BB-0BAA1409F6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D7DE910-8A9D-D2A0-E1E1-17A2166458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4C448-8B8E-4C87-A134-89449476375F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3BC02D-3751-4E63-4293-3B0AE97C24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49A2E8-9E37-4F1C-9E74-A96052B2F0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86444-F0C1-4D7F-8CD5-D22A45C5A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91811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840F3E-6CB1-4394-8313-B6BB44FC50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48464C-2648-A9BF-F987-1FC1CB7DC3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2976CA9-524D-908F-188D-CAF3A7ADFA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5CEAEA4-236C-9AA1-3C90-1037242E438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89DD166-0BF4-20EE-26E9-61857D60F76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3212BB6-BA1E-46B7-C1A0-FF59B3E888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4C448-8B8E-4C87-A134-89449476375F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41986EA-63B9-01AA-C78F-475A12DED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2998928-724B-BC1A-DDEF-77A907D459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86444-F0C1-4D7F-8CD5-D22A45C5A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39030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003420-F60A-F613-1311-0398591CC0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9B54CD1-A56F-DBBB-3384-B5B398ED50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4C448-8B8E-4C87-A134-89449476375F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A91338C-F5B3-4958-CEF0-DE8B5E85F1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B12C4B6-302D-3051-95EC-5FA111F2AE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86444-F0C1-4D7F-8CD5-D22A45C5A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15937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98D4827-04FA-720F-3984-FB17AE2C8C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4C448-8B8E-4C87-A134-89449476375F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4725C4B-8BF5-B5A2-C196-CA321EA1A9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6327CBA-51E5-EDC1-9625-BB0B345BF9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86444-F0C1-4D7F-8CD5-D22A45C5A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97695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CBA743-10C5-6F5A-EE82-06853BC623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BE67EE-25EB-75D0-A292-694355CB0A5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B9EB2C-8EF9-E34A-F59D-41B1E42EBBB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365512-2D50-7558-B064-F3491EC3E0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4C448-8B8E-4C87-A134-89449476375F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451F78-BF8B-2E4F-ACD9-32966E99B2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45916B-BAF3-903B-DD7D-DE72369A3C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86444-F0C1-4D7F-8CD5-D22A45C5A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5155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424665-2097-6F27-855C-03F8D17036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FFFEC03-D0AD-5EFC-98F1-EC64FFCD245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C8D168C-FB93-B048-0D3B-C927F6C03E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DB2314-EBE6-DD68-123B-B79063043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4C448-8B8E-4C87-A134-89449476375F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2D7328-5F8C-390A-6DA2-90793FDC80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1C4B3D-B6D4-94E0-8E3D-74E595A2E8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86444-F0C1-4D7F-8CD5-D22A45C5A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2277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4F36EF4-F6E7-A739-592D-B8C91E1C2F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077852B-2D6A-05A7-1697-DC1B1F1876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989C81-8CB0-38F9-2BD5-8F4DAF36C4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04C448-8B8E-4C87-A134-89449476375F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C198D9-610F-7B34-E045-B06F21B6C99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31749D-A31A-D1D3-D76C-B0067DF2E5B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186444-F0C1-4D7F-8CD5-D22A45C5A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67608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4" name="Group 103">
            <a:extLst>
              <a:ext uri="{FF2B5EF4-FFF2-40B4-BE49-F238E27FC236}">
                <a16:creationId xmlns:a16="http://schemas.microsoft.com/office/drawing/2014/main" id="{8D78D7A1-11C6-FA0B-128C-808FA86CB23A}"/>
              </a:ext>
            </a:extLst>
          </p:cNvPr>
          <p:cNvGrpSpPr/>
          <p:nvPr/>
        </p:nvGrpSpPr>
        <p:grpSpPr>
          <a:xfrm>
            <a:off x="984751" y="327373"/>
            <a:ext cx="7328193" cy="6030589"/>
            <a:chOff x="6136978" y="-16507"/>
            <a:chExt cx="5971602" cy="492883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2576510E-8462-4B03-3701-1DB753CBF8E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485073" y="173290"/>
              <a:ext cx="5623507" cy="4739033"/>
            </a:xfrm>
            <a:prstGeom prst="rect">
              <a:avLst/>
            </a:prstGeom>
          </p:spPr>
        </p:pic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3CEBF357-BDFD-BF8B-7CDD-5B1A9FDF647D}"/>
                </a:ext>
              </a:extLst>
            </p:cNvPr>
            <p:cNvSpPr txBox="1"/>
            <p:nvPr/>
          </p:nvSpPr>
          <p:spPr>
            <a:xfrm>
              <a:off x="6728849" y="-16507"/>
              <a:ext cx="544656" cy="226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solidFill>
                    <a:srgbClr val="D0009A"/>
                  </a:solidFill>
                  <a:latin typeface="Arial Nova" panose="020B0504020202020204" pitchFamily="34" charset="0"/>
                </a:rPr>
                <a:t>Tubulin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21AABA71-A6B3-58D2-E874-59F0CA1702C9}"/>
                </a:ext>
              </a:extLst>
            </p:cNvPr>
            <p:cNvSpPr txBox="1"/>
            <p:nvPr/>
          </p:nvSpPr>
          <p:spPr>
            <a:xfrm>
              <a:off x="7430981" y="-16507"/>
              <a:ext cx="933503" cy="226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err="1">
                  <a:solidFill>
                    <a:srgbClr val="FF0000"/>
                  </a:solidFill>
                  <a:latin typeface="Arial Nova" panose="020B0504020202020204" pitchFamily="34" charset="0"/>
                </a:rPr>
                <a:t>mCherry</a:t>
              </a:r>
              <a:r>
                <a:rPr lang="en-GB" sz="1200" dirty="0">
                  <a:solidFill>
                    <a:srgbClr val="FF0000"/>
                  </a:solidFill>
                  <a:latin typeface="Arial Nova" panose="020B0504020202020204" pitchFamily="34" charset="0"/>
                </a:rPr>
                <a:t>(Ran)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C8F1DB1F-CE01-1337-8CA5-63F70B194CF6}"/>
                </a:ext>
              </a:extLst>
            </p:cNvPr>
            <p:cNvSpPr txBox="1"/>
            <p:nvPr/>
          </p:nvSpPr>
          <p:spPr>
            <a:xfrm>
              <a:off x="8436194" y="-16507"/>
              <a:ext cx="1013759" cy="226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solidFill>
                    <a:srgbClr val="00B050"/>
                  </a:solidFill>
                  <a:latin typeface="Arial Nova" panose="020B0504020202020204" pitchFamily="34" charset="0"/>
                </a:rPr>
                <a:t>FITC (PlexinB1)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BD8E81C4-72D1-D3B8-AFF3-7593D844894F}"/>
                </a:ext>
              </a:extLst>
            </p:cNvPr>
            <p:cNvSpPr txBox="1"/>
            <p:nvPr/>
          </p:nvSpPr>
          <p:spPr>
            <a:xfrm>
              <a:off x="9539067" y="-16507"/>
              <a:ext cx="427355" cy="226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solidFill>
                    <a:srgbClr val="0000FF"/>
                  </a:solidFill>
                  <a:latin typeface="Arial Nova" panose="020B0504020202020204" pitchFamily="34" charset="0"/>
                </a:rPr>
                <a:t>DAPI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14578E48-A7F0-BF1C-54BF-00AEA2AF215F}"/>
                </a:ext>
              </a:extLst>
            </p:cNvPr>
            <p:cNvSpPr txBox="1"/>
            <p:nvPr/>
          </p:nvSpPr>
          <p:spPr>
            <a:xfrm>
              <a:off x="10340591" y="-16507"/>
              <a:ext cx="508499" cy="226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merge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9E5AB21E-357A-8E68-B421-47B6F939DB5D}"/>
                </a:ext>
              </a:extLst>
            </p:cNvPr>
            <p:cNvSpPr txBox="1"/>
            <p:nvPr/>
          </p:nvSpPr>
          <p:spPr>
            <a:xfrm>
              <a:off x="11329076" y="-16507"/>
              <a:ext cx="450920" cy="226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zoom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7554706C-2D84-3C2D-61D4-DEA72F329CB9}"/>
                </a:ext>
              </a:extLst>
            </p:cNvPr>
            <p:cNvSpPr txBox="1"/>
            <p:nvPr/>
          </p:nvSpPr>
          <p:spPr>
            <a:xfrm rot="16200000">
              <a:off x="6152368" y="520040"/>
              <a:ext cx="533595" cy="2257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control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1748B95C-ABB8-71A1-160C-95AEDAA977B8}"/>
                </a:ext>
              </a:extLst>
            </p:cNvPr>
            <p:cNvSpPr txBox="1"/>
            <p:nvPr/>
          </p:nvSpPr>
          <p:spPr>
            <a:xfrm rot="16200000">
              <a:off x="5737685" y="1248470"/>
              <a:ext cx="1178297" cy="3762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PlexinB1</a:t>
              </a:r>
            </a:p>
            <a:p>
              <a:r>
                <a:rPr lang="en-GB" sz="1200" dirty="0">
                  <a:latin typeface="Arial Nova" panose="020B0504020202020204" pitchFamily="34" charset="0"/>
                </a:rPr>
                <a:t>/</a:t>
              </a:r>
              <a:r>
                <a:rPr lang="en-GB" sz="1200" dirty="0" err="1">
                  <a:latin typeface="Arial Nova" panose="020B0504020202020204" pitchFamily="34" charset="0"/>
                </a:rPr>
                <a:t>mCherry</a:t>
              </a:r>
              <a:endParaRPr lang="en-GB" sz="1200" dirty="0">
                <a:latin typeface="Arial Nova" panose="020B0504020202020204" pitchFamily="34" charset="0"/>
              </a:endParaRP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153E640B-D066-0E89-D095-30E65CD42034}"/>
                </a:ext>
              </a:extLst>
            </p:cNvPr>
            <p:cNvSpPr txBox="1"/>
            <p:nvPr/>
          </p:nvSpPr>
          <p:spPr>
            <a:xfrm rot="16200000">
              <a:off x="5644284" y="2108941"/>
              <a:ext cx="1365099" cy="3762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PlexinB1</a:t>
              </a:r>
            </a:p>
            <a:p>
              <a:r>
                <a:rPr lang="en-GB" sz="1200" dirty="0">
                  <a:latin typeface="Arial Nova" panose="020B0504020202020204" pitchFamily="34" charset="0"/>
                </a:rPr>
                <a:t>/</a:t>
              </a:r>
              <a:r>
                <a:rPr lang="en-GB" sz="1200" dirty="0" err="1">
                  <a:latin typeface="Arial Nova" panose="020B0504020202020204" pitchFamily="34" charset="0"/>
                </a:rPr>
                <a:t>RanWT</a:t>
              </a:r>
              <a:endParaRPr lang="en-GB" sz="1200" dirty="0">
                <a:latin typeface="Arial Nova" panose="020B0504020202020204" pitchFamily="34" charset="0"/>
              </a:endParaRP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6E2A0325-B850-EBD7-F20A-7D24F3923B3F}"/>
                </a:ext>
              </a:extLst>
            </p:cNvPr>
            <p:cNvSpPr txBox="1"/>
            <p:nvPr/>
          </p:nvSpPr>
          <p:spPr>
            <a:xfrm rot="16200000">
              <a:off x="5615673" y="3025600"/>
              <a:ext cx="1422317" cy="3762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PlexinB1</a:t>
              </a:r>
            </a:p>
            <a:p>
              <a:r>
                <a:rPr lang="en-GB" sz="1200" dirty="0">
                  <a:latin typeface="Arial Nova" panose="020B0504020202020204" pitchFamily="34" charset="0"/>
                </a:rPr>
                <a:t>/RanQ69L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C99A4415-BD8D-E3E9-7170-3F50D4B3B56E}"/>
                </a:ext>
              </a:extLst>
            </p:cNvPr>
            <p:cNvSpPr txBox="1"/>
            <p:nvPr/>
          </p:nvSpPr>
          <p:spPr>
            <a:xfrm rot="16200000">
              <a:off x="5575920" y="3728124"/>
              <a:ext cx="1498318" cy="3762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PlexinB1</a:t>
              </a:r>
            </a:p>
            <a:p>
              <a:r>
                <a:rPr lang="en-GB" sz="1200" dirty="0">
                  <a:latin typeface="Arial Nova" panose="020B0504020202020204" pitchFamily="34" charset="0"/>
                </a:rPr>
                <a:t>/RanT24N</a:t>
              </a:r>
            </a:p>
          </p:txBody>
        </p:sp>
      </p:grpSp>
      <p:sp>
        <p:nvSpPr>
          <p:cNvPr id="101" name="TextBox 100">
            <a:extLst>
              <a:ext uri="{FF2B5EF4-FFF2-40B4-BE49-F238E27FC236}">
                <a16:creationId xmlns:a16="http://schemas.microsoft.com/office/drawing/2014/main" id="{820712E9-E28E-EAAD-7675-7C03E59AB1B5}"/>
              </a:ext>
            </a:extLst>
          </p:cNvPr>
          <p:cNvSpPr txBox="1"/>
          <p:nvPr/>
        </p:nvSpPr>
        <p:spPr>
          <a:xfrm>
            <a:off x="886906" y="13188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 Nova" panose="020B0504020202020204" pitchFamily="34" charset="0"/>
              </a:rPr>
              <a:t>A</a:t>
            </a:r>
          </a:p>
        </p:txBody>
      </p:sp>
      <p:grpSp>
        <p:nvGrpSpPr>
          <p:cNvPr id="121" name="Group 120">
            <a:extLst>
              <a:ext uri="{FF2B5EF4-FFF2-40B4-BE49-F238E27FC236}">
                <a16:creationId xmlns:a16="http://schemas.microsoft.com/office/drawing/2014/main" id="{44D2073B-B1C3-C0FC-9280-65E178C21AC3}"/>
              </a:ext>
            </a:extLst>
          </p:cNvPr>
          <p:cNvGrpSpPr/>
          <p:nvPr/>
        </p:nvGrpSpPr>
        <p:grpSpPr>
          <a:xfrm>
            <a:off x="8872292" y="1562857"/>
            <a:ext cx="2391510" cy="1838402"/>
            <a:chOff x="6164439" y="5066949"/>
            <a:chExt cx="2391510" cy="1838402"/>
          </a:xfrm>
        </p:grpSpPr>
        <p:grpSp>
          <p:nvGrpSpPr>
            <p:cNvPr id="105" name="Group 104">
              <a:extLst>
                <a:ext uri="{FF2B5EF4-FFF2-40B4-BE49-F238E27FC236}">
                  <a16:creationId xmlns:a16="http://schemas.microsoft.com/office/drawing/2014/main" id="{9608B634-11F9-D572-5AB2-91BA0D746AF1}"/>
                </a:ext>
              </a:extLst>
            </p:cNvPr>
            <p:cNvGrpSpPr/>
            <p:nvPr/>
          </p:nvGrpSpPr>
          <p:grpSpPr>
            <a:xfrm>
              <a:off x="6164439" y="5066949"/>
              <a:ext cx="2391510" cy="1838402"/>
              <a:chOff x="6164439" y="5066949"/>
              <a:chExt cx="2391510" cy="1838402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F3D577FE-482D-7EA0-6BCA-1A7C408E68B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627900" y="5066949"/>
                <a:ext cx="1825292" cy="1264970"/>
              </a:xfrm>
              <a:prstGeom prst="rect">
                <a:avLst/>
              </a:prstGeom>
            </p:spPr>
          </p:pic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8FEDA8C2-C9CC-5B98-7FDF-27E3A2B713FE}"/>
                  </a:ext>
                </a:extLst>
              </p:cNvPr>
              <p:cNvSpPr txBox="1"/>
              <p:nvPr/>
            </p:nvSpPr>
            <p:spPr>
              <a:xfrm rot="19082536">
                <a:off x="6214439" y="6139495"/>
                <a:ext cx="131707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 Nova" panose="020B0504020202020204" pitchFamily="34" charset="0"/>
                  </a:rPr>
                  <a:t>control</a:t>
                </a: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9777C26B-BBAD-A680-6780-4CE3A59AF71F}"/>
                  </a:ext>
                </a:extLst>
              </p:cNvPr>
              <p:cNvSpPr txBox="1"/>
              <p:nvPr/>
            </p:nvSpPr>
            <p:spPr>
              <a:xfrm rot="19082536">
                <a:off x="6601110" y="6386759"/>
                <a:ext cx="7779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 Nova" panose="020B0504020202020204" pitchFamily="34" charset="0"/>
                  </a:rPr>
                  <a:t>PlexinB1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222FB30A-E971-E130-A8EF-C2DBE616F5AA}"/>
                  </a:ext>
                </a:extLst>
              </p:cNvPr>
              <p:cNvSpPr txBox="1"/>
              <p:nvPr/>
            </p:nvSpPr>
            <p:spPr>
              <a:xfrm rot="19082536">
                <a:off x="6447904" y="6571070"/>
                <a:ext cx="136749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 Nova" panose="020B0504020202020204" pitchFamily="34" charset="0"/>
                  </a:rPr>
                  <a:t>RanWT+PlexinB1</a:t>
                </a: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40A1972E-D825-47BA-D3C3-DFE856FA6B58}"/>
                  </a:ext>
                </a:extLst>
              </p:cNvPr>
              <p:cNvSpPr txBox="1"/>
              <p:nvPr/>
            </p:nvSpPr>
            <p:spPr>
              <a:xfrm rot="19082536">
                <a:off x="6692836" y="6617662"/>
                <a:ext cx="15072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 Nova" panose="020B0504020202020204" pitchFamily="34" charset="0"/>
                  </a:rPr>
                  <a:t>RanQ69L+PlexinB1</a:t>
                </a:r>
              </a:p>
            </p:txBody>
          </p: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A5833CA1-7899-56F7-EBB7-717F3D163438}"/>
                  </a:ext>
                </a:extLst>
              </p:cNvPr>
              <p:cNvSpPr txBox="1"/>
              <p:nvPr/>
            </p:nvSpPr>
            <p:spPr>
              <a:xfrm rot="19082536">
                <a:off x="7053486" y="6628352"/>
                <a:ext cx="150246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 Nova" panose="020B0504020202020204" pitchFamily="34" charset="0"/>
                  </a:rPr>
                  <a:t>RanT24N+PlexinB1</a:t>
                </a: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8ADB43E8-0BD4-A16F-A55D-24238A1F26CC}"/>
                  </a:ext>
                </a:extLst>
              </p:cNvPr>
              <p:cNvSpPr txBox="1"/>
              <p:nvPr/>
            </p:nvSpPr>
            <p:spPr>
              <a:xfrm rot="16200000">
                <a:off x="5626311" y="5621362"/>
                <a:ext cx="135325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 Nova" panose="020B0504020202020204" pitchFamily="34" charset="0"/>
                  </a:rPr>
                  <a:t>% collapsed cells</a:t>
                </a:r>
              </a:p>
            </p:txBody>
          </p:sp>
        </p:grpSp>
        <p:grpSp>
          <p:nvGrpSpPr>
            <p:cNvPr id="112" name="Group 111">
              <a:extLst>
                <a:ext uri="{FF2B5EF4-FFF2-40B4-BE49-F238E27FC236}">
                  <a16:creationId xmlns:a16="http://schemas.microsoft.com/office/drawing/2014/main" id="{C5582967-5073-574F-819F-4BC381BFA595}"/>
                </a:ext>
              </a:extLst>
            </p:cNvPr>
            <p:cNvGrpSpPr/>
            <p:nvPr/>
          </p:nvGrpSpPr>
          <p:grpSpPr>
            <a:xfrm>
              <a:off x="6323476" y="5089795"/>
              <a:ext cx="415043" cy="1298067"/>
              <a:chOff x="6323476" y="5089795"/>
              <a:chExt cx="415043" cy="1298067"/>
            </a:xfrm>
          </p:grpSpPr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B61067CE-C87E-F0DD-7962-00922ED8CDC6}"/>
                  </a:ext>
                </a:extLst>
              </p:cNvPr>
              <p:cNvSpPr txBox="1"/>
              <p:nvPr/>
            </p:nvSpPr>
            <p:spPr>
              <a:xfrm>
                <a:off x="6323476" y="5089795"/>
                <a:ext cx="37702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 Nova" panose="020B0504020202020204" pitchFamily="34" charset="0"/>
                  </a:rPr>
                  <a:t>100</a:t>
                </a: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2BCC9855-C2B2-3633-D9C0-229A63111319}"/>
                  </a:ext>
                </a:extLst>
              </p:cNvPr>
              <p:cNvSpPr txBox="1"/>
              <p:nvPr/>
            </p:nvSpPr>
            <p:spPr>
              <a:xfrm>
                <a:off x="6381184" y="5334407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 Nova" panose="020B0504020202020204" pitchFamily="34" charset="0"/>
                  </a:rPr>
                  <a:t>80</a:t>
                </a:r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E1DB7AB0-5604-89AE-192C-E8CD8A69B2E5}"/>
                  </a:ext>
                </a:extLst>
              </p:cNvPr>
              <p:cNvSpPr txBox="1"/>
              <p:nvPr/>
            </p:nvSpPr>
            <p:spPr>
              <a:xfrm>
                <a:off x="6381184" y="5582048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 Nova" panose="020B0504020202020204" pitchFamily="34" charset="0"/>
                  </a:rPr>
                  <a:t>60</a:t>
                </a: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43DD35F2-FE01-7C0C-C4EC-9D6ECD8CA0AE}"/>
                  </a:ext>
                </a:extLst>
              </p:cNvPr>
              <p:cNvSpPr txBox="1"/>
              <p:nvPr/>
            </p:nvSpPr>
            <p:spPr>
              <a:xfrm>
                <a:off x="6381184" y="5790658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 Nova" panose="020B0504020202020204" pitchFamily="34" charset="0"/>
                  </a:rPr>
                  <a:t>40</a:t>
                </a: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A6A2E9FB-AD37-D9F7-90F1-71D2B8C20B91}"/>
                  </a:ext>
                </a:extLst>
              </p:cNvPr>
              <p:cNvSpPr txBox="1"/>
              <p:nvPr/>
            </p:nvSpPr>
            <p:spPr>
              <a:xfrm>
                <a:off x="6381184" y="6032588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 Nova" panose="020B0504020202020204" pitchFamily="34" charset="0"/>
                  </a:rPr>
                  <a:t>20</a:t>
                </a: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1CD0E9AB-8B80-B192-68C3-9CF2D03F0DFC}"/>
                  </a:ext>
                </a:extLst>
              </p:cNvPr>
              <p:cNvSpPr txBox="1"/>
              <p:nvPr/>
            </p:nvSpPr>
            <p:spPr>
              <a:xfrm>
                <a:off x="6489733" y="6157030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 Nova" panose="020B0504020202020204" pitchFamily="34" charset="0"/>
                  </a:rPr>
                  <a:t>0</a:t>
                </a:r>
              </a:p>
            </p:txBody>
          </p:sp>
        </p:grpSp>
      </p:grpSp>
      <p:grpSp>
        <p:nvGrpSpPr>
          <p:cNvPr id="120" name="Group 119">
            <a:extLst>
              <a:ext uri="{FF2B5EF4-FFF2-40B4-BE49-F238E27FC236}">
                <a16:creationId xmlns:a16="http://schemas.microsoft.com/office/drawing/2014/main" id="{A56A9FD5-F194-609C-30B8-A90F90D0D3BF}"/>
              </a:ext>
            </a:extLst>
          </p:cNvPr>
          <p:cNvGrpSpPr/>
          <p:nvPr/>
        </p:nvGrpSpPr>
        <p:grpSpPr>
          <a:xfrm>
            <a:off x="9003854" y="3972079"/>
            <a:ext cx="2288708" cy="1966354"/>
            <a:chOff x="8913315" y="4953621"/>
            <a:chExt cx="2288708" cy="1966354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A3F579EB-9FAC-F9B8-D622-A88A9454295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344819" y="4953621"/>
              <a:ext cx="1742573" cy="1378297"/>
            </a:xfrm>
            <a:prstGeom prst="rect">
              <a:avLst/>
            </a:prstGeom>
          </p:spPr>
        </p:pic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33D243D5-1298-0750-F5AC-A2F817F58F14}"/>
                </a:ext>
              </a:extLst>
            </p:cNvPr>
            <p:cNvSpPr txBox="1"/>
            <p:nvPr/>
          </p:nvSpPr>
          <p:spPr>
            <a:xfrm rot="16200000">
              <a:off x="8375187" y="5629311"/>
              <a:ext cx="13532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% collapsed cells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39D7F409-17AE-FA86-9D82-C58396FE5145}"/>
                </a:ext>
              </a:extLst>
            </p:cNvPr>
            <p:cNvSpPr txBox="1"/>
            <p:nvPr/>
          </p:nvSpPr>
          <p:spPr>
            <a:xfrm rot="19082536">
              <a:off x="9315550" y="6427021"/>
              <a:ext cx="7779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PlexinB1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517A5609-42E8-9255-BEBD-0DE94168326C}"/>
                </a:ext>
              </a:extLst>
            </p:cNvPr>
            <p:cNvSpPr txBox="1"/>
            <p:nvPr/>
          </p:nvSpPr>
          <p:spPr>
            <a:xfrm rot="19082536">
              <a:off x="9145252" y="6602786"/>
              <a:ext cx="13674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RanWT+PlexinB1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43A3FD90-B348-D1C7-1BFA-BBAAD13DB95F}"/>
                </a:ext>
              </a:extLst>
            </p:cNvPr>
            <p:cNvSpPr txBox="1"/>
            <p:nvPr/>
          </p:nvSpPr>
          <p:spPr>
            <a:xfrm rot="19082536">
              <a:off x="9364546" y="6640832"/>
              <a:ext cx="15072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RanQ69L+PlexinB1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59BAD3F8-FD39-53AE-957E-D9B111F93B87}"/>
                </a:ext>
              </a:extLst>
            </p:cNvPr>
            <p:cNvSpPr txBox="1"/>
            <p:nvPr/>
          </p:nvSpPr>
          <p:spPr>
            <a:xfrm rot="19082536">
              <a:off x="9699560" y="6642976"/>
              <a:ext cx="15024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RanT24N+PlexinB1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F9FC6185-3580-FF00-ACB9-09CC7B03EC59}"/>
                </a:ext>
              </a:extLst>
            </p:cNvPr>
            <p:cNvSpPr txBox="1"/>
            <p:nvPr/>
          </p:nvSpPr>
          <p:spPr>
            <a:xfrm rot="19082536">
              <a:off x="8972010" y="6179757"/>
              <a:ext cx="1317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control</a:t>
              </a:r>
            </a:p>
          </p:txBody>
        </p:sp>
        <p:grpSp>
          <p:nvGrpSpPr>
            <p:cNvPr id="113" name="Group 112">
              <a:extLst>
                <a:ext uri="{FF2B5EF4-FFF2-40B4-BE49-F238E27FC236}">
                  <a16:creationId xmlns:a16="http://schemas.microsoft.com/office/drawing/2014/main" id="{2E5BB356-1D5C-E6E6-4283-9F26C02CA0CA}"/>
                </a:ext>
              </a:extLst>
            </p:cNvPr>
            <p:cNvGrpSpPr/>
            <p:nvPr/>
          </p:nvGrpSpPr>
          <p:grpSpPr>
            <a:xfrm>
              <a:off x="9042890" y="5066948"/>
              <a:ext cx="377026" cy="1331896"/>
              <a:chOff x="6323476" y="5089795"/>
              <a:chExt cx="377026" cy="1331896"/>
            </a:xfrm>
          </p:grpSpPr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2A72B70B-50B7-97DA-A503-B9D7C04250C9}"/>
                  </a:ext>
                </a:extLst>
              </p:cNvPr>
              <p:cNvSpPr txBox="1"/>
              <p:nvPr/>
            </p:nvSpPr>
            <p:spPr>
              <a:xfrm>
                <a:off x="6323476" y="5089795"/>
                <a:ext cx="37702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 Nova" panose="020B0504020202020204" pitchFamily="34" charset="0"/>
                  </a:rPr>
                  <a:t>100</a:t>
                </a: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615F7B0F-AE35-E980-1765-863436A58BFC}"/>
                  </a:ext>
                </a:extLst>
              </p:cNvPr>
              <p:cNvSpPr txBox="1"/>
              <p:nvPr/>
            </p:nvSpPr>
            <p:spPr>
              <a:xfrm>
                <a:off x="6381184" y="5334407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 Nova" panose="020B0504020202020204" pitchFamily="34" charset="0"/>
                  </a:rPr>
                  <a:t>80</a:t>
                </a:r>
              </a:p>
            </p:txBody>
          </p: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4D004B0E-7BCC-3196-9C3F-27765A2817FA}"/>
                  </a:ext>
                </a:extLst>
              </p:cNvPr>
              <p:cNvSpPr txBox="1"/>
              <p:nvPr/>
            </p:nvSpPr>
            <p:spPr>
              <a:xfrm>
                <a:off x="6381184" y="5582048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 Nova" panose="020B0504020202020204" pitchFamily="34" charset="0"/>
                  </a:rPr>
                  <a:t>60</a:t>
                </a:r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914BB10D-D6D8-F2F4-CCBB-CBE94B75363E}"/>
                  </a:ext>
                </a:extLst>
              </p:cNvPr>
              <p:cNvSpPr txBox="1"/>
              <p:nvPr/>
            </p:nvSpPr>
            <p:spPr>
              <a:xfrm>
                <a:off x="6381184" y="5790658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 Nova" panose="020B0504020202020204" pitchFamily="34" charset="0"/>
                  </a:rPr>
                  <a:t>40</a:t>
                </a:r>
              </a:p>
            </p:txBody>
          </p: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07C514FD-B41C-7343-4BB4-E22D185554BE}"/>
                  </a:ext>
                </a:extLst>
              </p:cNvPr>
              <p:cNvSpPr txBox="1"/>
              <p:nvPr/>
            </p:nvSpPr>
            <p:spPr>
              <a:xfrm>
                <a:off x="6381184" y="6032588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 Nova" panose="020B0504020202020204" pitchFamily="34" charset="0"/>
                  </a:rPr>
                  <a:t>20</a:t>
                </a:r>
              </a:p>
            </p:txBody>
          </p:sp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8C12B988-C36D-DD66-E856-DFA8BF96A649}"/>
                  </a:ext>
                </a:extLst>
              </p:cNvPr>
              <p:cNvSpPr txBox="1"/>
              <p:nvPr/>
            </p:nvSpPr>
            <p:spPr>
              <a:xfrm>
                <a:off x="6437983" y="6190859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 Nova" panose="020B0504020202020204" pitchFamily="34" charset="0"/>
                  </a:rPr>
                  <a:t>0</a:t>
                </a:r>
              </a:p>
            </p:txBody>
          </p:sp>
        </p:grpSp>
      </p:grpSp>
      <p:sp>
        <p:nvSpPr>
          <p:cNvPr id="124" name="TextBox 123">
            <a:extLst>
              <a:ext uri="{FF2B5EF4-FFF2-40B4-BE49-F238E27FC236}">
                <a16:creationId xmlns:a16="http://schemas.microsoft.com/office/drawing/2014/main" id="{013B2F88-A6AE-0DBF-01C8-E9171CB7C950}"/>
              </a:ext>
            </a:extLst>
          </p:cNvPr>
          <p:cNvSpPr txBox="1"/>
          <p:nvPr/>
        </p:nvSpPr>
        <p:spPr>
          <a:xfrm>
            <a:off x="16696993" y="1452238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 Nova" panose="020B0504020202020204" pitchFamily="34" charset="0"/>
              </a:rPr>
              <a:t>D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86030CB7-D5BF-CB4E-7B63-377412C52AE3}"/>
              </a:ext>
            </a:extLst>
          </p:cNvPr>
          <p:cNvSpPr txBox="1"/>
          <p:nvPr/>
        </p:nvSpPr>
        <p:spPr>
          <a:xfrm>
            <a:off x="16010567" y="4943998"/>
            <a:ext cx="7713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 Nova" panose="020B0504020202020204" pitchFamily="34" charset="0"/>
              </a:rPr>
              <a:t>Sema4D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267BA4E2-F986-D194-2FEA-A1764726DC28}"/>
              </a:ext>
            </a:extLst>
          </p:cNvPr>
          <p:cNvSpPr txBox="1"/>
          <p:nvPr/>
        </p:nvSpPr>
        <p:spPr>
          <a:xfrm>
            <a:off x="16010567" y="3790520"/>
            <a:ext cx="652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 Nova" panose="020B0504020202020204" pitchFamily="34" charset="0"/>
              </a:rPr>
              <a:t>control</a:t>
            </a:r>
          </a:p>
        </p:txBody>
      </p:sp>
      <p:cxnSp>
        <p:nvCxnSpPr>
          <p:cNvPr id="192" name="Straight Connector 191">
            <a:extLst>
              <a:ext uri="{FF2B5EF4-FFF2-40B4-BE49-F238E27FC236}">
                <a16:creationId xmlns:a16="http://schemas.microsoft.com/office/drawing/2014/main" id="{E9B52B9D-C9F4-6655-DA1C-2D7987384325}"/>
              </a:ext>
            </a:extLst>
          </p:cNvPr>
          <p:cNvCxnSpPr/>
          <p:nvPr/>
        </p:nvCxnSpPr>
        <p:spPr>
          <a:xfrm>
            <a:off x="596522" y="7754437"/>
            <a:ext cx="852319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29C80331-9BEB-4042-B699-40E88D816473}"/>
              </a:ext>
            </a:extLst>
          </p:cNvPr>
          <p:cNvSpPr txBox="1"/>
          <p:nvPr/>
        </p:nvSpPr>
        <p:spPr>
          <a:xfrm>
            <a:off x="8669497" y="1162532"/>
            <a:ext cx="335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 Nova" panose="020B0504020202020204" pitchFamily="34" charset="0"/>
              </a:rPr>
              <a:t>B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E2BCB8FB-C18D-4621-8FCA-693DBF549DBE}"/>
              </a:ext>
            </a:extLst>
          </p:cNvPr>
          <p:cNvSpPr txBox="1"/>
          <p:nvPr/>
        </p:nvSpPr>
        <p:spPr>
          <a:xfrm>
            <a:off x="8669497" y="3651866"/>
            <a:ext cx="3497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 Nova" panose="020B05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8456539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3BCDF811-EA98-47DD-8E82-80D04CB3C564}"/>
              </a:ext>
            </a:extLst>
          </p:cNvPr>
          <p:cNvSpPr/>
          <p:nvPr/>
        </p:nvSpPr>
        <p:spPr>
          <a:xfrm>
            <a:off x="1479082" y="1396021"/>
            <a:ext cx="9387840" cy="32004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5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exinB1 signals via Ran to induce morphological collapse 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).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Cos7 cells were transfected with empty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Cherry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vector, myc-PlexinB1 and empty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Cherry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vector, or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ycPlexin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B1 together with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Cherry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Ran(WT), RanQ69L or RanT24. Fixed were stained with anti-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yc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tibody to detect PlexinB1 and anti-tubulin antibody to detect microtubules. Cell images were taken using Eclipse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i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E inverted confocal microscope (Nikon) using x40 objective. Scale bar represents 20 µm. 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,C)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Data is expressed as the mean percentage ± standard error mean (SEM) of cells showing a collapsed phenotype (defined as cells with a contracted cell body with one or more extensions of greater length than the cell body). For control cells and PlexinB1 expressing cells n≥50 per 3 independent experiments. For PlexinB1/ Ran WT; PlexinB1/Q69L; PlexinB1/T24N n≥30 cells per 3 independent experiments. For all graph analysis, GraphPad Prism 6 software was used ****p&lt;0.0001, ns not significant; ordinary one-way ANOVA (analysis of variance) with Tukey post-hoc test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12561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7</Words>
  <Application>Microsoft Office PowerPoint</Application>
  <PresentationFormat>Widescreen</PresentationFormat>
  <Paragraphs>4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Arial Nova</vt:lpstr>
      <vt:lpstr>Calibri</vt:lpstr>
      <vt:lpstr>Calibri Light</vt:lpstr>
      <vt:lpstr>Office Theme</vt:lpstr>
      <vt:lpstr>PowerPoint Presentation</vt:lpstr>
      <vt:lpstr>PowerPoint Presentation</vt:lpstr>
    </vt:vector>
  </TitlesOfParts>
  <Company>KC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gali Williamson</dc:creator>
  <cp:lastModifiedBy>Magali Williamson</cp:lastModifiedBy>
  <cp:revision>1</cp:revision>
  <dcterms:created xsi:type="dcterms:W3CDTF">2023-06-02T16:41:48Z</dcterms:created>
  <dcterms:modified xsi:type="dcterms:W3CDTF">2023-06-02T16:42:44Z</dcterms:modified>
</cp:coreProperties>
</file>